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CR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CR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400" b="0" i="0" u="none" strike="noStrike" kern="1200" cap="all" spc="0" normalizeH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de-DE" sz="1400" b="0" i="0" u="none" strike="noStrike" kern="1200" spc="0" baseline="0" dirty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rPr>
              <a:t>Gene Expressio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400" b="0" i="0" u="none" strike="noStrike" kern="1200" cap="all" spc="0" normalizeH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4.7222222222222221E-2"/>
          <c:y val="0.22669036162146397"/>
          <c:w val="0.93888888888888888"/>
          <c:h val="0.623579396325459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2!$P$1</c:f>
              <c:strCache>
                <c:ptCount val="1"/>
                <c:pt idx="0">
                  <c:v>iso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abelle2!$O$2:$O$9</c:f>
              <c:strCache>
                <c:ptCount val="8"/>
                <c:pt idx="0">
                  <c:v>CCL1</c:v>
                </c:pt>
                <c:pt idx="1">
                  <c:v>CCL-20</c:v>
                </c:pt>
                <c:pt idx="2">
                  <c:v>CCL7</c:v>
                </c:pt>
                <c:pt idx="3">
                  <c:v>CCL8</c:v>
                </c:pt>
                <c:pt idx="4">
                  <c:v>IL-8</c:v>
                </c:pt>
                <c:pt idx="5">
                  <c:v>IL-alpha</c:v>
                </c:pt>
                <c:pt idx="6">
                  <c:v>IL-beta</c:v>
                </c:pt>
                <c:pt idx="7">
                  <c:v>IL-6</c:v>
                </c:pt>
              </c:strCache>
            </c:strRef>
          </c:cat>
          <c:val>
            <c:numRef>
              <c:f>Tabelle2!$P$2:$P$9</c:f>
              <c:numCache>
                <c:formatCode>General</c:formatCode>
                <c:ptCount val="8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34-4A87-B355-2EA982F0C6B0}"/>
            </c:ext>
          </c:extLst>
        </c:ser>
        <c:ser>
          <c:idx val="1"/>
          <c:order val="1"/>
          <c:tx>
            <c:strRef>
              <c:f>Tabelle2!$Q$1</c:f>
              <c:strCache>
                <c:ptCount val="1"/>
                <c:pt idx="0">
                  <c:v>18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abelle2!$O$2:$O$9</c:f>
              <c:strCache>
                <c:ptCount val="8"/>
                <c:pt idx="0">
                  <c:v>CCL1</c:v>
                </c:pt>
                <c:pt idx="1">
                  <c:v>CCL-20</c:v>
                </c:pt>
                <c:pt idx="2">
                  <c:v>CCL7</c:v>
                </c:pt>
                <c:pt idx="3">
                  <c:v>CCL8</c:v>
                </c:pt>
                <c:pt idx="4">
                  <c:v>IL-8</c:v>
                </c:pt>
                <c:pt idx="5">
                  <c:v>IL-alpha</c:v>
                </c:pt>
                <c:pt idx="6">
                  <c:v>IL-beta</c:v>
                </c:pt>
                <c:pt idx="7">
                  <c:v>IL-6</c:v>
                </c:pt>
              </c:strCache>
            </c:strRef>
          </c:cat>
          <c:val>
            <c:numRef>
              <c:f>Tabelle2!$Q$2:$Q$9</c:f>
              <c:numCache>
                <c:formatCode>General</c:formatCode>
                <c:ptCount val="8"/>
                <c:pt idx="0">
                  <c:v>73</c:v>
                </c:pt>
                <c:pt idx="1">
                  <c:v>142</c:v>
                </c:pt>
                <c:pt idx="3">
                  <c:v>0.17199999999999999</c:v>
                </c:pt>
                <c:pt idx="4">
                  <c:v>10.15</c:v>
                </c:pt>
                <c:pt idx="5">
                  <c:v>194</c:v>
                </c:pt>
                <c:pt idx="6">
                  <c:v>70</c:v>
                </c:pt>
                <c:pt idx="7">
                  <c:v>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534-4A87-B355-2EA982F0C6B0}"/>
            </c:ext>
          </c:extLst>
        </c:ser>
        <c:ser>
          <c:idx val="2"/>
          <c:order val="2"/>
          <c:tx>
            <c:strRef>
              <c:f>Tabelle2!$R$1</c:f>
              <c:strCache>
                <c:ptCount val="1"/>
                <c:pt idx="0">
                  <c:v>138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abelle2!$O$2:$O$9</c:f>
              <c:strCache>
                <c:ptCount val="8"/>
                <c:pt idx="0">
                  <c:v>CCL1</c:v>
                </c:pt>
                <c:pt idx="1">
                  <c:v>CCL-20</c:v>
                </c:pt>
                <c:pt idx="2">
                  <c:v>CCL7</c:v>
                </c:pt>
                <c:pt idx="3">
                  <c:v>CCL8</c:v>
                </c:pt>
                <c:pt idx="4">
                  <c:v>IL-8</c:v>
                </c:pt>
                <c:pt idx="5">
                  <c:v>IL-alpha</c:v>
                </c:pt>
                <c:pt idx="6">
                  <c:v>IL-beta</c:v>
                </c:pt>
                <c:pt idx="7">
                  <c:v>IL-6</c:v>
                </c:pt>
              </c:strCache>
            </c:strRef>
          </c:cat>
          <c:val>
            <c:numRef>
              <c:f>Tabelle2!$R$2:$R$9</c:f>
              <c:numCache>
                <c:formatCode>General</c:formatCode>
                <c:ptCount val="8"/>
                <c:pt idx="2">
                  <c:v>0.45</c:v>
                </c:pt>
                <c:pt idx="3">
                  <c:v>0.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534-4A87-B355-2EA982F0C6B0}"/>
            </c:ext>
          </c:extLst>
        </c:ser>
        <c:ser>
          <c:idx val="3"/>
          <c:order val="3"/>
          <c:tx>
            <c:strRef>
              <c:f>Tabelle2!$S$1</c:f>
              <c:strCache>
                <c:ptCount val="1"/>
                <c:pt idx="0">
                  <c:v>15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abelle2!$O$2:$O$9</c:f>
              <c:strCache>
                <c:ptCount val="8"/>
                <c:pt idx="0">
                  <c:v>CCL1</c:v>
                </c:pt>
                <c:pt idx="1">
                  <c:v>CCL-20</c:v>
                </c:pt>
                <c:pt idx="2">
                  <c:v>CCL7</c:v>
                </c:pt>
                <c:pt idx="3">
                  <c:v>CCL8</c:v>
                </c:pt>
                <c:pt idx="4">
                  <c:v>IL-8</c:v>
                </c:pt>
                <c:pt idx="5">
                  <c:v>IL-alpha</c:v>
                </c:pt>
                <c:pt idx="6">
                  <c:v>IL-beta</c:v>
                </c:pt>
                <c:pt idx="7">
                  <c:v>IL-6</c:v>
                </c:pt>
              </c:strCache>
            </c:strRef>
          </c:cat>
          <c:val>
            <c:numRef>
              <c:f>Tabelle2!$S$2:$S$9</c:f>
              <c:numCache>
                <c:formatCode>General</c:formatCode>
                <c:ptCount val="8"/>
                <c:pt idx="2">
                  <c:v>0.26</c:v>
                </c:pt>
                <c:pt idx="3">
                  <c:v>0.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534-4A87-B355-2EA982F0C6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304914704"/>
        <c:axId val="302635216"/>
      </c:barChart>
      <c:catAx>
        <c:axId val="30491470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02635216"/>
        <c:crosses val="autoZero"/>
        <c:auto val="1"/>
        <c:lblAlgn val="ctr"/>
        <c:lblOffset val="100"/>
        <c:noMultiLvlLbl val="0"/>
      </c:catAx>
      <c:valAx>
        <c:axId val="302635216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3049147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/>
              <a:t>Gene expressio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2!$P$1</c:f>
              <c:strCache>
                <c:ptCount val="1"/>
                <c:pt idx="0">
                  <c:v>iso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Tabelle2!$O$2:$O$9</c:f>
              <c:strCache>
                <c:ptCount val="8"/>
                <c:pt idx="0">
                  <c:v>CCL1</c:v>
                </c:pt>
                <c:pt idx="1">
                  <c:v>CCL-20</c:v>
                </c:pt>
                <c:pt idx="2">
                  <c:v>CCL7</c:v>
                </c:pt>
                <c:pt idx="3">
                  <c:v>CCL8</c:v>
                </c:pt>
                <c:pt idx="4">
                  <c:v>IL-8</c:v>
                </c:pt>
                <c:pt idx="5">
                  <c:v>IL-alpha</c:v>
                </c:pt>
                <c:pt idx="6">
                  <c:v>IL-beta</c:v>
                </c:pt>
                <c:pt idx="7">
                  <c:v>IL-6</c:v>
                </c:pt>
              </c:strCache>
            </c:strRef>
          </c:cat>
          <c:val>
            <c:numRef>
              <c:f>Tabelle2!$P$2:$P$9</c:f>
              <c:numCache>
                <c:formatCode>General</c:formatCode>
                <c:ptCount val="8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9E-48E3-AFEF-7CC660AA2878}"/>
            </c:ext>
          </c:extLst>
        </c:ser>
        <c:ser>
          <c:idx val="1"/>
          <c:order val="1"/>
          <c:tx>
            <c:strRef>
              <c:f>Tabelle2!$Q$1</c:f>
              <c:strCache>
                <c:ptCount val="1"/>
                <c:pt idx="0">
                  <c:v>18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Tabelle2!$O$2:$O$9</c:f>
              <c:strCache>
                <c:ptCount val="8"/>
                <c:pt idx="0">
                  <c:v>CCL1</c:v>
                </c:pt>
                <c:pt idx="1">
                  <c:v>CCL-20</c:v>
                </c:pt>
                <c:pt idx="2">
                  <c:v>CCL7</c:v>
                </c:pt>
                <c:pt idx="3">
                  <c:v>CCL8</c:v>
                </c:pt>
                <c:pt idx="4">
                  <c:v>IL-8</c:v>
                </c:pt>
                <c:pt idx="5">
                  <c:v>IL-alpha</c:v>
                </c:pt>
                <c:pt idx="6">
                  <c:v>IL-beta</c:v>
                </c:pt>
                <c:pt idx="7">
                  <c:v>IL-6</c:v>
                </c:pt>
              </c:strCache>
            </c:strRef>
          </c:cat>
          <c:val>
            <c:numRef>
              <c:f>Tabelle2!$Q$2:$Q$9</c:f>
              <c:numCache>
                <c:formatCode>General</c:formatCode>
                <c:ptCount val="8"/>
                <c:pt idx="0">
                  <c:v>73</c:v>
                </c:pt>
                <c:pt idx="1">
                  <c:v>142</c:v>
                </c:pt>
                <c:pt idx="3">
                  <c:v>0.17199999999999999</c:v>
                </c:pt>
                <c:pt idx="4">
                  <c:v>10.15</c:v>
                </c:pt>
                <c:pt idx="5">
                  <c:v>194</c:v>
                </c:pt>
                <c:pt idx="6">
                  <c:v>70</c:v>
                </c:pt>
                <c:pt idx="7">
                  <c:v>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9E-48E3-AFEF-7CC660AA2878}"/>
            </c:ext>
          </c:extLst>
        </c:ser>
        <c:ser>
          <c:idx val="2"/>
          <c:order val="2"/>
          <c:tx>
            <c:strRef>
              <c:f>Tabelle2!$R$1</c:f>
              <c:strCache>
                <c:ptCount val="1"/>
                <c:pt idx="0">
                  <c:v>138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Tabelle2!$O$2:$O$9</c:f>
              <c:strCache>
                <c:ptCount val="8"/>
                <c:pt idx="0">
                  <c:v>CCL1</c:v>
                </c:pt>
                <c:pt idx="1">
                  <c:v>CCL-20</c:v>
                </c:pt>
                <c:pt idx="2">
                  <c:v>CCL7</c:v>
                </c:pt>
                <c:pt idx="3">
                  <c:v>CCL8</c:v>
                </c:pt>
                <c:pt idx="4">
                  <c:v>IL-8</c:v>
                </c:pt>
                <c:pt idx="5">
                  <c:v>IL-alpha</c:v>
                </c:pt>
                <c:pt idx="6">
                  <c:v>IL-beta</c:v>
                </c:pt>
                <c:pt idx="7">
                  <c:v>IL-6</c:v>
                </c:pt>
              </c:strCache>
            </c:strRef>
          </c:cat>
          <c:val>
            <c:numRef>
              <c:f>Tabelle2!$R$2:$R$9</c:f>
              <c:numCache>
                <c:formatCode>General</c:formatCode>
                <c:ptCount val="8"/>
                <c:pt idx="2">
                  <c:v>0.45</c:v>
                </c:pt>
                <c:pt idx="3">
                  <c:v>0.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C9E-48E3-AFEF-7CC660AA2878}"/>
            </c:ext>
          </c:extLst>
        </c:ser>
        <c:ser>
          <c:idx val="3"/>
          <c:order val="3"/>
          <c:tx>
            <c:strRef>
              <c:f>Tabelle2!$S$1</c:f>
              <c:strCache>
                <c:ptCount val="1"/>
                <c:pt idx="0">
                  <c:v>15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Tabelle2!$O$2:$O$9</c:f>
              <c:strCache>
                <c:ptCount val="8"/>
                <c:pt idx="0">
                  <c:v>CCL1</c:v>
                </c:pt>
                <c:pt idx="1">
                  <c:v>CCL-20</c:v>
                </c:pt>
                <c:pt idx="2">
                  <c:v>CCL7</c:v>
                </c:pt>
                <c:pt idx="3">
                  <c:v>CCL8</c:v>
                </c:pt>
                <c:pt idx="4">
                  <c:v>IL-8</c:v>
                </c:pt>
                <c:pt idx="5">
                  <c:v>IL-alpha</c:v>
                </c:pt>
                <c:pt idx="6">
                  <c:v>IL-beta</c:v>
                </c:pt>
                <c:pt idx="7">
                  <c:v>IL-6</c:v>
                </c:pt>
              </c:strCache>
            </c:strRef>
          </c:cat>
          <c:val>
            <c:numRef>
              <c:f>Tabelle2!$S$2:$S$9</c:f>
              <c:numCache>
                <c:formatCode>General</c:formatCode>
                <c:ptCount val="8"/>
                <c:pt idx="2">
                  <c:v>0.26</c:v>
                </c:pt>
                <c:pt idx="3">
                  <c:v>0.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C9E-48E3-AFEF-7CC660AA28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2382328"/>
        <c:axId val="402382984"/>
      </c:barChart>
      <c:catAx>
        <c:axId val="4023823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2382984"/>
        <c:crosses val="autoZero"/>
        <c:auto val="1"/>
        <c:lblAlgn val="ctr"/>
        <c:lblOffset val="100"/>
        <c:noMultiLvlLbl val="0"/>
      </c:catAx>
      <c:valAx>
        <c:axId val="402382984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23823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0372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2601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9197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4092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1373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1793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9530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099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2898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5435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4495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B1F4A-CFF6-4990-BD1C-450FC7DEF9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1943B-8C7F-4F04-AFC9-C84880F311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8051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Diagramm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464565"/>
              </p:ext>
            </p:extLst>
          </p:nvPr>
        </p:nvGraphicFramePr>
        <p:xfrm>
          <a:off x="6628015" y="151707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Rechteck 3"/>
          <p:cNvSpPr/>
          <p:nvPr/>
        </p:nvSpPr>
        <p:spPr>
          <a:xfrm>
            <a:off x="2000597" y="4469054"/>
            <a:ext cx="6096000" cy="1092607"/>
          </a:xfrm>
          <a:prstGeom prst="rect">
            <a:avLst/>
          </a:prstGeom>
        </p:spPr>
        <p:txBody>
          <a:bodyPr>
            <a:spAutoFit/>
          </a:bodyPr>
          <a:lstStyle/>
          <a:p>
            <a:pPr indent="269875" algn="just">
              <a:lnSpc>
                <a:spcPts val="13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fferently </a:t>
            </a: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gulated genes confirmed by RT-PCR:</a:t>
            </a:r>
            <a:endParaRPr lang="de-DE" sz="12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269875" algn="just">
              <a:lnSpc>
                <a:spcPts val="13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me differently regulated genes of interest were confirmed by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PCR. In the figure, their relative quantitation compared to the vehicle (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so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octane) is displayed. </a:t>
            </a:r>
            <a:r>
              <a:rPr lang="en-US" sz="12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firmed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regulated genes for PCB </a:t>
            </a:r>
            <a:r>
              <a:rPr lang="en-US" sz="12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80 included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L-1, CCL-20, IL-α, IL-β, IL-6</a:t>
            </a:r>
            <a:r>
              <a:rPr lang="en-US" sz="12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indent="269875" algn="just">
              <a:lnSpc>
                <a:spcPts val="1300"/>
              </a:lnSpc>
              <a:spcAft>
                <a:spcPts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firmed downregulated genes for PCB 180, 138 and 180 included CCL-7 and CCL-8.</a:t>
            </a:r>
            <a:endParaRPr lang="de-DE" sz="12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Diagram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0947880"/>
              </p:ext>
            </p:extLst>
          </p:nvPr>
        </p:nvGraphicFramePr>
        <p:xfrm>
          <a:off x="2000597" y="162146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837415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Breitbild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</vt:lpstr>
      <vt:lpstr>PowerPoint-Präsentation</vt:lpstr>
    </vt:vector>
  </TitlesOfParts>
  <Company>Universitätsklinikum Aachen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ijs, Marike</dc:creator>
  <cp:lastModifiedBy>Leijs, Marike</cp:lastModifiedBy>
  <cp:revision>5</cp:revision>
  <dcterms:created xsi:type="dcterms:W3CDTF">2019-05-20T10:32:50Z</dcterms:created>
  <dcterms:modified xsi:type="dcterms:W3CDTF">2019-05-21T12:03:16Z</dcterms:modified>
</cp:coreProperties>
</file>